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3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36B792-3BCA-47C3-9F91-5A5793C4EE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317982-5924-44C4-A92F-108A89A935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041EDD-9A7E-42C3-9C1C-FF6F41512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3A89C6-81B2-4AC9-81CD-0F17C079A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A2E881-5724-424A-8920-D3A5FD7F1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155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A51F88-27B6-4716-8739-94F1426FCB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935770-6DEA-4387-AB40-ABDF72C32F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DE8E77-5828-45B9-A8E1-F37275BAB3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0C867B-B9D3-4C03-A074-9F86040BB6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D24EDB-0F25-4938-959A-DEAA31B68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138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0431A7-6B95-43B0-9978-9ED4274410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647678-CEDB-454E-ABFF-B1C5F4F6A8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048837-6C76-4107-9560-3273D8CF03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9A3DC0-201B-4F6C-8990-75516526A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C0D8A7-C9D6-4786-87D7-85E5D8548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729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EE6C7B-C1E8-438E-B889-DC872554F3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8FE2C4-B3B4-4C9F-8E19-BB6C5992B6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3BA332-E647-467E-BFFC-294BA4A19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4BB03C-EB61-46BD-AE70-6D52D2CF5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428BBB-9803-474D-B208-91F4543ABF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092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1B4E57-ADEA-46DB-AC3F-21AEC1556E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824D17-8FE3-49EE-BF70-E314AA11ED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1D5685-E16D-48F1-9F48-846845303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557B03-D1E0-4FA4-B737-5128DFBEB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87FBE8-8BE3-41E2-A6ED-4B5C025F55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942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A0A682-7084-43E9-930D-019E536E0E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5F0430-C4BD-4F33-91B6-4464A5FFBF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088E5D-BFEE-45CC-B364-7DE2CD34F6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139DCD-1354-4556-99BA-FC7620112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5160C2-163B-4B3D-B9AD-89703E8E47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61FE45-66DF-4EBF-B34B-0BAAF24E31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600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1D4E9F-3CF6-4679-8899-B4ECA4FBE1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69CC0E-C2A9-4572-AEEB-ECD0EEE8DC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AF3BC0-C949-4091-B723-48DD320ADF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216F677-6575-44E2-A492-A8A63B9DD4C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D2494F2-FB8B-41A6-9958-AE49B4ECAA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1F61A63-4EC3-443E-B52F-5721BAAA9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F4FB5A3-E65B-4151-A4A7-85BECF20E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DA9EC3A-C131-4C43-8F58-553F21D44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222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B45ACD-F304-46D5-9A20-9FCB449375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02EBAF-AAED-4FD7-83D4-BEB2235DB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F745874-87AC-495E-BD20-577493690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F5A9B6F-CF86-424F-BBD9-DFDD7681C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615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FFC10A9-0CD8-4F09-AB20-44EBF646B5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5BE0BDB-7A73-4ADB-8CE5-651D8146A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D23207-0D62-4C16-8EBC-6D6358E47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9987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ED2F15-FA85-4349-ADEF-C815D0F41C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23E580-87E6-4165-A85A-031C5D99AB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9BCAE7-30B1-442F-B93B-16AD9F00B9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06639B-8FD5-430D-B44A-F6026BC375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7C2D7F-CB72-425D-B4E8-777FAD3E6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8E1A14-3FAF-449E-9ED1-86DF3AE93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510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E1FF6A-231C-4AFC-8856-F2323D320D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6B9BF82-87AC-47CF-94ED-05E22C02B4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B66C52-4B71-4399-A8C0-E967365A49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A91A42-5041-406C-BF90-C56062D58C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26C2AF-494B-46BA-87F2-D9EEE4F471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C8B764-8086-4EC1-8FE6-2B03EC426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7243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90C972-388D-4F0E-84B6-F79FCA577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367DC9-E91E-4A9A-B781-0F85B150C1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AB059C-C464-48A4-8EAC-A2386F28F1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413BFC-A5CB-4E9C-B655-AAE0854F6E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060B30-2F1C-4EDB-BB01-29D405F2DA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139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0D305E0-64B6-42E4-B182-D90AFF7D40FC}"/>
              </a:ext>
            </a:extLst>
          </p:cNvPr>
          <p:cNvGrpSpPr/>
          <p:nvPr/>
        </p:nvGrpSpPr>
        <p:grpSpPr>
          <a:xfrm>
            <a:off x="3027015" y="-77886"/>
            <a:ext cx="5805700" cy="6391138"/>
            <a:chOff x="3369591" y="76587"/>
            <a:chExt cx="3123488" cy="320379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051502C-E246-4D8A-8B39-8FFA29E7F7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5784" b="35081"/>
            <a:stretch/>
          </p:blipFill>
          <p:spPr>
            <a:xfrm>
              <a:off x="3369592" y="218933"/>
              <a:ext cx="3123487" cy="926483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255094B-8FA4-40FD-B097-C4C8056786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t="36594" r="1748" b="34438"/>
            <a:stretch/>
          </p:blipFill>
          <p:spPr>
            <a:xfrm>
              <a:off x="3369591" y="2331465"/>
              <a:ext cx="3123487" cy="94892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918B041C-EA80-4826-AD76-A17BFAE9C9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6724" b="34141"/>
            <a:stretch/>
          </p:blipFill>
          <p:spPr>
            <a:xfrm>
              <a:off x="3369591" y="1275199"/>
              <a:ext cx="3123487" cy="926483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599D22A-8A3B-48E6-863F-3D7CFE03FAB9}"/>
                </a:ext>
              </a:extLst>
            </p:cNvPr>
            <p:cNvSpPr txBox="1"/>
            <p:nvPr/>
          </p:nvSpPr>
          <p:spPr>
            <a:xfrm>
              <a:off x="3404710" y="76587"/>
              <a:ext cx="262517" cy="1642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</a:rPr>
                <a:t>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24E5BC7-2CB3-4036-9B5C-1B9217B711EC}"/>
                </a:ext>
              </a:extLst>
            </p:cNvPr>
            <p:cNvSpPr txBox="1"/>
            <p:nvPr/>
          </p:nvSpPr>
          <p:spPr>
            <a:xfrm>
              <a:off x="3405892" y="1136699"/>
              <a:ext cx="262517" cy="1642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</a:rPr>
                <a:t>B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13504E0-5545-4F42-B367-7A10A0585E3C}"/>
                </a:ext>
              </a:extLst>
            </p:cNvPr>
            <p:cNvSpPr txBox="1"/>
            <p:nvPr/>
          </p:nvSpPr>
          <p:spPr>
            <a:xfrm>
              <a:off x="3404710" y="2192964"/>
              <a:ext cx="262517" cy="1642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</a:rPr>
                <a:t>C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EDAA374D-F69A-8B5F-1332-128747A42285}"/>
              </a:ext>
            </a:extLst>
          </p:cNvPr>
          <p:cNvSpPr txBox="1"/>
          <p:nvPr/>
        </p:nvSpPr>
        <p:spPr>
          <a:xfrm>
            <a:off x="1671131" y="6251100"/>
            <a:ext cx="884973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Figure S2: Mask R-CNN results (A. Ground Truth, B. Predictions, C. IOU of Ground Truth and Pre-dictions) on cropped RGB images obtained from wheat kernels’ HSI.</a:t>
            </a:r>
          </a:p>
        </p:txBody>
      </p:sp>
    </p:spTree>
    <p:extLst>
      <p:ext uri="{BB962C8B-B14F-4D97-AF65-F5344CB8AC3E}">
        <p14:creationId xmlns:p14="http://schemas.microsoft.com/office/powerpoint/2010/main" val="2164760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38C0679CE3F1146B99428810CFFD1A5" ma:contentTypeVersion="13" ma:contentTypeDescription="Create a new document." ma:contentTypeScope="" ma:versionID="87104e6739588b1d33bffce79ec9ef76">
  <xsd:schema xmlns:xsd="http://www.w3.org/2001/XMLSchema" xmlns:xs="http://www.w3.org/2001/XMLSchema" xmlns:p="http://schemas.microsoft.com/office/2006/metadata/properties" xmlns:ns3="9435e4ad-f246-4104-a637-66c8bc3c99a7" xmlns:ns4="64ecab17-5948-449f-a717-624ba6338b70" targetNamespace="http://schemas.microsoft.com/office/2006/metadata/properties" ma:root="true" ma:fieldsID="0405a160c580c868c8adfe7b1b3dd395" ns3:_="" ns4:_="">
    <xsd:import namespace="9435e4ad-f246-4104-a637-66c8bc3c99a7"/>
    <xsd:import namespace="64ecab17-5948-449f-a717-624ba6338b7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435e4ad-f246-4104-a637-66c8bc3c99a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7" nillable="true" ma:displayName="Tags" ma:internalName="MediaServiceAutoTags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4ecab17-5948-449f-a717-624ba6338b70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248906E8-DE11-4A8D-B10D-B4C87E15103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F7FADE4-FE2A-4329-A590-FAC15508CEB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435e4ad-f246-4104-a637-66c8bc3c99a7"/>
    <ds:schemaRef ds:uri="64ecab17-5948-449f-a717-624ba6338b7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23E2E658-AB97-4BC6-BFF3-5EDBC488DDD1}">
  <ds:schemaRefs>
    <ds:schemaRef ds:uri="http://schemas.microsoft.com/office/2006/metadata/properties"/>
    <ds:schemaRef ds:uri="9435e4ad-f246-4104-a637-66c8bc3c99a7"/>
    <ds:schemaRef ds:uri="http://schemas.openxmlformats.org/package/2006/metadata/core-properties"/>
    <ds:schemaRef ds:uri="http://www.w3.org/XML/1998/namespace"/>
    <ds:schemaRef ds:uri="http://schemas.microsoft.com/office/2006/documentManagement/types"/>
    <ds:schemaRef ds:uri="http://purl.org/dc/dcmitype/"/>
    <ds:schemaRef ds:uri="http://purl.org/dc/elements/1.1/"/>
    <ds:schemaRef ds:uri="64ecab17-5948-449f-a717-624ba6338b70"/>
    <ds:schemaRef ds:uri="http://purl.org/dc/terms/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9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Kshitiz</dc:creator>
  <cp:lastModifiedBy>song li</cp:lastModifiedBy>
  <cp:revision>3</cp:revision>
  <dcterms:created xsi:type="dcterms:W3CDTF">2022-10-18T21:50:26Z</dcterms:created>
  <dcterms:modified xsi:type="dcterms:W3CDTF">2023-03-28T00:17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38C0679CE3F1146B99428810CFFD1A5</vt:lpwstr>
  </property>
</Properties>
</file>